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4"/>
  </p:notesMasterIdLst>
  <p:sldIdLst>
    <p:sldId id="262" r:id="rId2"/>
    <p:sldId id="263" r:id="rId3"/>
    <p:sldId id="273" r:id="rId4"/>
    <p:sldId id="264" r:id="rId5"/>
    <p:sldId id="265" r:id="rId6"/>
    <p:sldId id="266" r:id="rId7"/>
    <p:sldId id="267" r:id="rId8"/>
    <p:sldId id="268" r:id="rId9"/>
    <p:sldId id="269" r:id="rId10"/>
    <p:sldId id="270" r:id="rId11"/>
    <p:sldId id="271" r:id="rId12"/>
    <p:sldId id="272" r:id="rId13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000000"/>
          </p15:clr>
        </p15:guide>
        <p15:guide id="2" pos="2160">
          <p15:clr>
            <a:srgbClr val="000000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9"/>
    <p:restoredTop sz="94721"/>
  </p:normalViewPr>
  <p:slideViewPr>
    <p:cSldViewPr snapToGrid="0">
      <p:cViewPr>
        <p:scale>
          <a:sx n="125" d="100"/>
          <a:sy n="125" d="100"/>
        </p:scale>
        <p:origin x="690" y="-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942574230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Google Shape;182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3" name="Google Shape;183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9063218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53" name="Google Shape;253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5964038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Google Shape;196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7" name="Google Shape;19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7833003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Google Shape;204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05" name="Google Shape;205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413455262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Google Shape;210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1" name="Google Shape;211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92289373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Google Shape;216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17" name="Google Shape;217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41594175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Google Shape;222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3" name="Google Shape;223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10943930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Google Shape;228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29" name="Google Shape;229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285875639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Google Shape;236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37" name="Google Shape;237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142951333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Google Shape;245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6" name="Google Shape;246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  <p:extLst>
      <p:ext uri="{BB962C8B-B14F-4D97-AF65-F5344CB8AC3E}">
        <p14:creationId xmlns:p14="http://schemas.microsoft.com/office/powerpoint/2010/main" val="382021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Font typeface="Arial"/>
              <a:buNone/>
              <a:defRPr sz="15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Font typeface="Arial"/>
              <a:buNone/>
              <a:defRPr sz="135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2" name="Google Shape;32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5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8" name="Google Shape;38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9" name="Google Shape;39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None/>
              <a:defRPr sz="135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None/>
              <a:defRPr sz="135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5" name="Google Shape;45;p6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6" name="Google Shape;46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Google Shape;47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7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3" name="Google Shape;53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Font typeface="Arial"/>
              <a:buNone/>
              <a:defRPr sz="10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Font typeface="Arial"/>
              <a:buNone/>
              <a:defRPr sz="10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Font typeface="Arial"/>
              <a:buNone/>
              <a:defRPr sz="7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Google Shape;185;p19"/>
          <p:cNvSpPr txBox="1"/>
          <p:nvPr/>
        </p:nvSpPr>
        <p:spPr>
          <a:xfrm>
            <a:off x="448496" y="5117190"/>
            <a:ext cx="5888598" cy="9603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 algn="ctr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altLang="zh-CN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</a:t>
            </a:r>
            <a:r>
              <a:rPr lang="en-U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</a:t>
            </a:r>
            <a:r>
              <a:rPr lang="zh-CN" altLang="en-US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altLang="zh-CN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ata model.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86" name="Google Shape;186;p19"/>
          <p:cNvGrpSpPr/>
          <p:nvPr/>
        </p:nvGrpSpPr>
        <p:grpSpPr>
          <a:xfrm>
            <a:off x="457201" y="537028"/>
            <a:ext cx="5566228" cy="4415972"/>
            <a:chOff x="-435429" y="1745343"/>
            <a:chExt cx="6858000" cy="5486400"/>
          </a:xfrm>
        </p:grpSpPr>
        <p:pic>
          <p:nvPicPr>
            <p:cNvPr id="187" name="Google Shape;187;p19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-435429" y="1745343"/>
              <a:ext cx="6858000" cy="54864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88" name="Google Shape;188;p19"/>
            <p:cNvSpPr/>
            <p:nvPr/>
          </p:nvSpPr>
          <p:spPr>
            <a:xfrm>
              <a:off x="3187700" y="4989568"/>
              <a:ext cx="328232" cy="72103"/>
            </a:xfrm>
            <a:custGeom>
              <a:avLst/>
              <a:gdLst/>
              <a:ahLst/>
              <a:cxnLst/>
              <a:rect l="l" t="t" r="r" b="b"/>
              <a:pathLst>
                <a:path w="241300" h="72103" extrusionOk="0">
                  <a:moveTo>
                    <a:pt x="0" y="5428"/>
                  </a:moveTo>
                  <a:lnTo>
                    <a:pt x="0" y="5428"/>
                  </a:lnTo>
                  <a:cubicBezTo>
                    <a:pt x="78900" y="-641"/>
                    <a:pt x="90863" y="-2893"/>
                    <a:pt x="203200" y="5428"/>
                  </a:cubicBezTo>
                  <a:cubicBezTo>
                    <a:pt x="207678" y="5760"/>
                    <a:pt x="209850" y="11504"/>
                    <a:pt x="212725" y="14953"/>
                  </a:cubicBezTo>
                  <a:cubicBezTo>
                    <a:pt x="237704" y="44928"/>
                    <a:pt x="203157" y="5364"/>
                    <a:pt x="222250" y="34003"/>
                  </a:cubicBezTo>
                  <a:cubicBezTo>
                    <a:pt x="224741" y="37739"/>
                    <a:pt x="228900" y="40079"/>
                    <a:pt x="231775" y="43528"/>
                  </a:cubicBezTo>
                  <a:cubicBezTo>
                    <a:pt x="238614" y="51734"/>
                    <a:pt x="238118" y="53032"/>
                    <a:pt x="241300" y="62578"/>
                  </a:cubicBezTo>
                  <a:cubicBezTo>
                    <a:pt x="238125" y="64695"/>
                    <a:pt x="235188" y="67221"/>
                    <a:pt x="231775" y="68928"/>
                  </a:cubicBezTo>
                  <a:cubicBezTo>
                    <a:pt x="228782" y="70425"/>
                    <a:pt x="225597" y="72103"/>
                    <a:pt x="222250" y="72103"/>
                  </a:cubicBezTo>
                  <a:cubicBezTo>
                    <a:pt x="158741" y="72103"/>
                    <a:pt x="95250" y="69986"/>
                    <a:pt x="31750" y="68928"/>
                  </a:cubicBezTo>
                  <a:cubicBezTo>
                    <a:pt x="28575" y="67870"/>
                    <a:pt x="24592" y="68120"/>
                    <a:pt x="22225" y="65753"/>
                  </a:cubicBezTo>
                  <a:cubicBezTo>
                    <a:pt x="16829" y="60357"/>
                    <a:pt x="11938" y="53943"/>
                    <a:pt x="9525" y="46703"/>
                  </a:cubicBezTo>
                  <a:cubicBezTo>
                    <a:pt x="5877" y="35758"/>
                    <a:pt x="1587" y="12307"/>
                    <a:pt x="0" y="5428"/>
                  </a:cubicBez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89" name="Google Shape;189;p19"/>
            <p:cNvSpPr/>
            <p:nvPr/>
          </p:nvSpPr>
          <p:spPr>
            <a:xfrm>
              <a:off x="3613105" y="4988847"/>
              <a:ext cx="292100" cy="72103"/>
            </a:xfrm>
            <a:custGeom>
              <a:avLst/>
              <a:gdLst/>
              <a:ahLst/>
              <a:cxnLst/>
              <a:rect l="l" t="t" r="r" b="b"/>
              <a:pathLst>
                <a:path w="241300" h="72103" extrusionOk="0">
                  <a:moveTo>
                    <a:pt x="0" y="5428"/>
                  </a:moveTo>
                  <a:lnTo>
                    <a:pt x="0" y="5428"/>
                  </a:lnTo>
                  <a:cubicBezTo>
                    <a:pt x="78900" y="-641"/>
                    <a:pt x="90863" y="-2893"/>
                    <a:pt x="203200" y="5428"/>
                  </a:cubicBezTo>
                  <a:cubicBezTo>
                    <a:pt x="207678" y="5760"/>
                    <a:pt x="209850" y="11504"/>
                    <a:pt x="212725" y="14953"/>
                  </a:cubicBezTo>
                  <a:cubicBezTo>
                    <a:pt x="237704" y="44928"/>
                    <a:pt x="203157" y="5364"/>
                    <a:pt x="222250" y="34003"/>
                  </a:cubicBezTo>
                  <a:cubicBezTo>
                    <a:pt x="224741" y="37739"/>
                    <a:pt x="228900" y="40079"/>
                    <a:pt x="231775" y="43528"/>
                  </a:cubicBezTo>
                  <a:cubicBezTo>
                    <a:pt x="238614" y="51734"/>
                    <a:pt x="238118" y="53032"/>
                    <a:pt x="241300" y="62578"/>
                  </a:cubicBezTo>
                  <a:cubicBezTo>
                    <a:pt x="238125" y="64695"/>
                    <a:pt x="235188" y="67221"/>
                    <a:pt x="231775" y="68928"/>
                  </a:cubicBezTo>
                  <a:cubicBezTo>
                    <a:pt x="228782" y="70425"/>
                    <a:pt x="225597" y="72103"/>
                    <a:pt x="222250" y="72103"/>
                  </a:cubicBezTo>
                  <a:cubicBezTo>
                    <a:pt x="158741" y="72103"/>
                    <a:pt x="95250" y="69986"/>
                    <a:pt x="31750" y="68928"/>
                  </a:cubicBezTo>
                  <a:cubicBezTo>
                    <a:pt x="28575" y="67870"/>
                    <a:pt x="24592" y="68120"/>
                    <a:pt x="22225" y="65753"/>
                  </a:cubicBezTo>
                  <a:cubicBezTo>
                    <a:pt x="16829" y="60357"/>
                    <a:pt x="11938" y="53943"/>
                    <a:pt x="9525" y="46703"/>
                  </a:cubicBezTo>
                  <a:cubicBezTo>
                    <a:pt x="5877" y="35758"/>
                    <a:pt x="1587" y="12307"/>
                    <a:pt x="0" y="5428"/>
                  </a:cubicBez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0" name="Google Shape;190;p19"/>
            <p:cNvSpPr/>
            <p:nvPr/>
          </p:nvSpPr>
          <p:spPr>
            <a:xfrm rot="1342741">
              <a:off x="3247019" y="4913280"/>
              <a:ext cx="306007" cy="95205"/>
            </a:xfrm>
            <a:custGeom>
              <a:avLst/>
              <a:gdLst/>
              <a:ahLst/>
              <a:cxnLst/>
              <a:rect l="l" t="t" r="r" b="b"/>
              <a:pathLst>
                <a:path w="241300" h="72103" extrusionOk="0">
                  <a:moveTo>
                    <a:pt x="0" y="5428"/>
                  </a:moveTo>
                  <a:lnTo>
                    <a:pt x="0" y="5428"/>
                  </a:lnTo>
                  <a:cubicBezTo>
                    <a:pt x="78900" y="-641"/>
                    <a:pt x="90863" y="-2893"/>
                    <a:pt x="203200" y="5428"/>
                  </a:cubicBezTo>
                  <a:cubicBezTo>
                    <a:pt x="207678" y="5760"/>
                    <a:pt x="209850" y="11504"/>
                    <a:pt x="212725" y="14953"/>
                  </a:cubicBezTo>
                  <a:cubicBezTo>
                    <a:pt x="237704" y="44928"/>
                    <a:pt x="203157" y="5364"/>
                    <a:pt x="222250" y="34003"/>
                  </a:cubicBezTo>
                  <a:cubicBezTo>
                    <a:pt x="224741" y="37739"/>
                    <a:pt x="228900" y="40079"/>
                    <a:pt x="231775" y="43528"/>
                  </a:cubicBezTo>
                  <a:cubicBezTo>
                    <a:pt x="238614" y="51734"/>
                    <a:pt x="238118" y="53032"/>
                    <a:pt x="241300" y="62578"/>
                  </a:cubicBezTo>
                  <a:cubicBezTo>
                    <a:pt x="238125" y="64695"/>
                    <a:pt x="235188" y="67221"/>
                    <a:pt x="231775" y="68928"/>
                  </a:cubicBezTo>
                  <a:cubicBezTo>
                    <a:pt x="228782" y="70425"/>
                    <a:pt x="225597" y="72103"/>
                    <a:pt x="222250" y="72103"/>
                  </a:cubicBezTo>
                  <a:cubicBezTo>
                    <a:pt x="158741" y="72103"/>
                    <a:pt x="95250" y="69986"/>
                    <a:pt x="31750" y="68928"/>
                  </a:cubicBezTo>
                  <a:cubicBezTo>
                    <a:pt x="28575" y="67870"/>
                    <a:pt x="24592" y="68120"/>
                    <a:pt x="22225" y="65753"/>
                  </a:cubicBezTo>
                  <a:cubicBezTo>
                    <a:pt x="16829" y="60357"/>
                    <a:pt x="11938" y="53943"/>
                    <a:pt x="9525" y="46703"/>
                  </a:cubicBezTo>
                  <a:cubicBezTo>
                    <a:pt x="5877" y="35758"/>
                    <a:pt x="1587" y="12307"/>
                    <a:pt x="0" y="5428"/>
                  </a:cubicBez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1" name="Google Shape;191;p19"/>
            <p:cNvSpPr/>
            <p:nvPr/>
          </p:nvSpPr>
          <p:spPr>
            <a:xfrm rot="866526">
              <a:off x="3577137" y="5000803"/>
              <a:ext cx="180975" cy="88900"/>
            </a:xfrm>
            <a:custGeom>
              <a:avLst/>
              <a:gdLst/>
              <a:ahLst/>
              <a:cxnLst/>
              <a:rect l="l" t="t" r="r" b="b"/>
              <a:pathLst>
                <a:path w="180975" h="88900" extrusionOk="0">
                  <a:moveTo>
                    <a:pt x="0" y="88900"/>
                  </a:moveTo>
                  <a:lnTo>
                    <a:pt x="0" y="88900"/>
                  </a:lnTo>
                  <a:cubicBezTo>
                    <a:pt x="10583" y="87842"/>
                    <a:pt x="22413" y="90818"/>
                    <a:pt x="31750" y="85725"/>
                  </a:cubicBezTo>
                  <a:cubicBezTo>
                    <a:pt x="36488" y="83141"/>
                    <a:pt x="34925" y="75246"/>
                    <a:pt x="34925" y="69850"/>
                  </a:cubicBezTo>
                  <a:cubicBezTo>
                    <a:pt x="34925" y="68640"/>
                    <a:pt x="30378" y="35957"/>
                    <a:pt x="28575" y="31750"/>
                  </a:cubicBezTo>
                  <a:cubicBezTo>
                    <a:pt x="27396" y="28999"/>
                    <a:pt x="24342" y="27517"/>
                    <a:pt x="22225" y="25400"/>
                  </a:cubicBezTo>
                  <a:lnTo>
                    <a:pt x="180975" y="0"/>
                  </a:lnTo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2" name="Google Shape;192;p19"/>
            <p:cNvSpPr/>
            <p:nvPr/>
          </p:nvSpPr>
          <p:spPr>
            <a:xfrm rot="1267287">
              <a:off x="3590870" y="4953000"/>
              <a:ext cx="180975" cy="88900"/>
            </a:xfrm>
            <a:custGeom>
              <a:avLst/>
              <a:gdLst/>
              <a:ahLst/>
              <a:cxnLst/>
              <a:rect l="l" t="t" r="r" b="b"/>
              <a:pathLst>
                <a:path w="180975" h="88900" extrusionOk="0">
                  <a:moveTo>
                    <a:pt x="0" y="88900"/>
                  </a:moveTo>
                  <a:lnTo>
                    <a:pt x="0" y="88900"/>
                  </a:lnTo>
                  <a:cubicBezTo>
                    <a:pt x="10583" y="87842"/>
                    <a:pt x="22413" y="90818"/>
                    <a:pt x="31750" y="85725"/>
                  </a:cubicBezTo>
                  <a:cubicBezTo>
                    <a:pt x="36488" y="83141"/>
                    <a:pt x="34925" y="75246"/>
                    <a:pt x="34925" y="69850"/>
                  </a:cubicBezTo>
                  <a:cubicBezTo>
                    <a:pt x="34925" y="68640"/>
                    <a:pt x="30378" y="35957"/>
                    <a:pt x="28575" y="31750"/>
                  </a:cubicBezTo>
                  <a:cubicBezTo>
                    <a:pt x="27396" y="28999"/>
                    <a:pt x="24342" y="27517"/>
                    <a:pt x="22225" y="25400"/>
                  </a:cubicBezTo>
                  <a:lnTo>
                    <a:pt x="180975" y="0"/>
                  </a:lnTo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3" name="Google Shape;193;p19"/>
            <p:cNvSpPr/>
            <p:nvPr/>
          </p:nvSpPr>
          <p:spPr>
            <a:xfrm rot="3618898">
              <a:off x="3351592" y="4953000"/>
              <a:ext cx="180975" cy="88900"/>
            </a:xfrm>
            <a:custGeom>
              <a:avLst/>
              <a:gdLst/>
              <a:ahLst/>
              <a:cxnLst/>
              <a:rect l="l" t="t" r="r" b="b"/>
              <a:pathLst>
                <a:path w="180975" h="88900" extrusionOk="0">
                  <a:moveTo>
                    <a:pt x="0" y="88900"/>
                  </a:moveTo>
                  <a:lnTo>
                    <a:pt x="0" y="88900"/>
                  </a:lnTo>
                  <a:cubicBezTo>
                    <a:pt x="10583" y="87842"/>
                    <a:pt x="22413" y="90818"/>
                    <a:pt x="31750" y="85725"/>
                  </a:cubicBezTo>
                  <a:cubicBezTo>
                    <a:pt x="36488" y="83141"/>
                    <a:pt x="34925" y="75246"/>
                    <a:pt x="34925" y="69850"/>
                  </a:cubicBezTo>
                  <a:cubicBezTo>
                    <a:pt x="34925" y="68640"/>
                    <a:pt x="30378" y="35957"/>
                    <a:pt x="28575" y="31750"/>
                  </a:cubicBezTo>
                  <a:cubicBezTo>
                    <a:pt x="27396" y="28999"/>
                    <a:pt x="24342" y="27517"/>
                    <a:pt x="22225" y="25400"/>
                  </a:cubicBezTo>
                  <a:lnTo>
                    <a:pt x="180975" y="0"/>
                  </a:lnTo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94" name="Google Shape;194;p19"/>
            <p:cNvSpPr/>
            <p:nvPr/>
          </p:nvSpPr>
          <p:spPr>
            <a:xfrm rot="1302039">
              <a:off x="3216890" y="4907418"/>
              <a:ext cx="306007" cy="95205"/>
            </a:xfrm>
            <a:custGeom>
              <a:avLst/>
              <a:gdLst/>
              <a:ahLst/>
              <a:cxnLst/>
              <a:rect l="l" t="t" r="r" b="b"/>
              <a:pathLst>
                <a:path w="241300" h="72103" extrusionOk="0">
                  <a:moveTo>
                    <a:pt x="0" y="5428"/>
                  </a:moveTo>
                  <a:lnTo>
                    <a:pt x="0" y="5428"/>
                  </a:lnTo>
                  <a:cubicBezTo>
                    <a:pt x="78900" y="-641"/>
                    <a:pt x="90863" y="-2893"/>
                    <a:pt x="203200" y="5428"/>
                  </a:cubicBezTo>
                  <a:cubicBezTo>
                    <a:pt x="207678" y="5760"/>
                    <a:pt x="209850" y="11504"/>
                    <a:pt x="212725" y="14953"/>
                  </a:cubicBezTo>
                  <a:cubicBezTo>
                    <a:pt x="237704" y="44928"/>
                    <a:pt x="203157" y="5364"/>
                    <a:pt x="222250" y="34003"/>
                  </a:cubicBezTo>
                  <a:cubicBezTo>
                    <a:pt x="224741" y="37739"/>
                    <a:pt x="228900" y="40079"/>
                    <a:pt x="231775" y="43528"/>
                  </a:cubicBezTo>
                  <a:cubicBezTo>
                    <a:pt x="238614" y="51734"/>
                    <a:pt x="238118" y="53032"/>
                    <a:pt x="241300" y="62578"/>
                  </a:cubicBezTo>
                  <a:cubicBezTo>
                    <a:pt x="238125" y="64695"/>
                    <a:pt x="235188" y="67221"/>
                    <a:pt x="231775" y="68928"/>
                  </a:cubicBezTo>
                  <a:cubicBezTo>
                    <a:pt x="228782" y="70425"/>
                    <a:pt x="225597" y="72103"/>
                    <a:pt x="222250" y="72103"/>
                  </a:cubicBezTo>
                  <a:cubicBezTo>
                    <a:pt x="158741" y="72103"/>
                    <a:pt x="95250" y="69986"/>
                    <a:pt x="31750" y="68928"/>
                  </a:cubicBezTo>
                  <a:cubicBezTo>
                    <a:pt x="28575" y="67870"/>
                    <a:pt x="24592" y="68120"/>
                    <a:pt x="22225" y="65753"/>
                  </a:cubicBezTo>
                  <a:cubicBezTo>
                    <a:pt x="16829" y="60357"/>
                    <a:pt x="11938" y="53943"/>
                    <a:pt x="9525" y="46703"/>
                  </a:cubicBezTo>
                  <a:cubicBezTo>
                    <a:pt x="5877" y="35758"/>
                    <a:pt x="1587" y="12307"/>
                    <a:pt x="0" y="5428"/>
                  </a:cubicBezTo>
                  <a:close/>
                </a:path>
              </a:pathLst>
            </a:cu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</a:pPr>
              <a:endParaRPr sz="14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8" name="Google Shape;248;p27"/>
          <p:cNvSpPr txBox="1"/>
          <p:nvPr/>
        </p:nvSpPr>
        <p:spPr>
          <a:xfrm>
            <a:off x="120316" y="83043"/>
            <a:ext cx="6642434" cy="5034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6. </a:t>
            </a:r>
            <a:r>
              <a:rPr lang="en-GB" dirty="0"/>
              <a:t>Heatmap representing ROMA scores averaged between the three studies, separating disease groups and controls. 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9" name="Google Shape;249;p27" descr="C:\Users\User\Downloads\S1.png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081087" y="586538"/>
            <a:ext cx="4434951" cy="3250672"/>
          </a:xfrm>
          <a:prstGeom prst="rect">
            <a:avLst/>
          </a:prstGeom>
          <a:noFill/>
          <a:ln>
            <a:noFill/>
          </a:ln>
        </p:spPr>
      </p:pic>
      <p:pic>
        <p:nvPicPr>
          <p:cNvPr id="250" name="Google Shape;250;p27" descr="C:\Users\User\Downloads\S2.png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016008" y="4498520"/>
            <a:ext cx="4500030" cy="3298373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28"/>
          <p:cNvSpPr txBox="1"/>
          <p:nvPr/>
        </p:nvSpPr>
        <p:spPr>
          <a:xfrm>
            <a:off x="120315" y="83043"/>
            <a:ext cx="6304238" cy="5265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7. </a:t>
            </a:r>
            <a:r>
              <a:rPr lang="en-GB" dirty="0"/>
              <a:t>Heatmap representing the Enrichment scores, from Gene Set Enrichment Analysis, averaged between the three studies.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56" name="Google Shape;256;p28"/>
          <p:cNvPicPr preferRelativeResize="0"/>
          <p:nvPr/>
        </p:nvPicPr>
        <p:blipFill rotWithShape="1">
          <a:blip r:embed="rId3">
            <a:alphaModFix/>
          </a:blip>
          <a:srcRect l="27986" t="22670" r="16046" b="17342"/>
          <a:stretch/>
        </p:blipFill>
        <p:spPr>
          <a:xfrm>
            <a:off x="525861" y="681564"/>
            <a:ext cx="5806278" cy="364800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255;p28"/>
          <p:cNvSpPr txBox="1"/>
          <p:nvPr/>
        </p:nvSpPr>
        <p:spPr>
          <a:xfrm>
            <a:off x="120316" y="83043"/>
            <a:ext cx="1452642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8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026" name="Picture 2" descr="C:\Users\bioinfo\Documents\RCD Paper\Heat;ap GSEA ordered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7690" y="405464"/>
            <a:ext cx="3724275" cy="3108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7797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Google Shape;199;p20"/>
          <p:cNvSpPr txBox="1"/>
          <p:nvPr/>
        </p:nvSpPr>
        <p:spPr>
          <a:xfrm>
            <a:off x="175735" y="97246"/>
            <a:ext cx="6384721" cy="36721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+mj-lt"/>
                <a:ea typeface="Calibri"/>
                <a:cs typeface="Adobe Devanagari" panose="02040503050201020203" pitchFamily="18" charset="0"/>
                <a:sym typeface="Calibri"/>
              </a:rPr>
              <a:t>Figure S2. </a:t>
            </a:r>
            <a:r>
              <a:rPr lang="en-GB" sz="1000" dirty="0">
                <a:latin typeface="+mj-lt"/>
                <a:cs typeface="Adobe Devanagari" panose="02040503050201020203" pitchFamily="18" charset="0"/>
              </a:rPr>
              <a:t>Annotation page on an entity on RCD map using </a:t>
            </a:r>
            <a:r>
              <a:rPr lang="en-GB" sz="1000" dirty="0" err="1">
                <a:latin typeface="+mj-lt"/>
                <a:cs typeface="Adobe Devanagari" panose="02040503050201020203" pitchFamily="18" charset="0"/>
              </a:rPr>
              <a:t>NaviCell</a:t>
            </a:r>
            <a:r>
              <a:rPr lang="en-GB" sz="1000" dirty="0">
                <a:latin typeface="+mj-lt"/>
                <a:cs typeface="Adobe Devanagari" panose="02040503050201020203" pitchFamily="18" charset="0"/>
              </a:rPr>
              <a:t> format</a:t>
            </a:r>
            <a:r>
              <a:rPr lang="en-GB" dirty="0">
                <a:latin typeface="Adobe Devanagari" panose="02040503050201020203" pitchFamily="18" charset="0"/>
                <a:cs typeface="Adobe Devanagari" panose="02040503050201020203" pitchFamily="18" charset="0"/>
              </a:rPr>
              <a:t>.</a:t>
            </a:r>
            <a:endParaRPr sz="1000" b="1" i="0" u="none" strike="noStrike" cap="none" dirty="0">
              <a:solidFill>
                <a:schemeClr val="dk1"/>
              </a:solidFill>
              <a:latin typeface="Adobe Devanagari" panose="02040503050201020203" pitchFamily="18" charset="0"/>
              <a:ea typeface="Calibri"/>
              <a:cs typeface="Adobe Devanagari" panose="02040503050201020203" pitchFamily="18" charset="0"/>
              <a:sym typeface="Calibri"/>
            </a:endParaRPr>
          </a:p>
        </p:txBody>
      </p:sp>
      <p:pic>
        <p:nvPicPr>
          <p:cNvPr id="200" name="Google Shape;200;p2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63119" y="343467"/>
            <a:ext cx="4866081" cy="3116982"/>
          </a:xfrm>
          <a:prstGeom prst="rect">
            <a:avLst/>
          </a:prstGeom>
          <a:noFill/>
          <a:ln>
            <a:noFill/>
          </a:ln>
        </p:spPr>
      </p:pic>
      <p:pic>
        <p:nvPicPr>
          <p:cNvPr id="201" name="Google Shape;201;p20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76974" y="3449967"/>
            <a:ext cx="3674590" cy="3216697"/>
          </a:xfrm>
          <a:prstGeom prst="rect">
            <a:avLst/>
          </a:prstGeom>
          <a:noFill/>
          <a:ln>
            <a:noFill/>
          </a:ln>
        </p:spPr>
      </p:pic>
      <p:pic>
        <p:nvPicPr>
          <p:cNvPr id="202" name="Google Shape;202;p20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175736" y="6693761"/>
            <a:ext cx="6238920" cy="314871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8F6B9C6D-2F98-6B46-B5CC-59F8D1FA3D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788" y="767295"/>
            <a:ext cx="3035477" cy="323272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7F892B5-FC9D-1245-BB17-3324E5C3ED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1440" y="643389"/>
            <a:ext cx="3077739" cy="353090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51D27BEE-0D3E-2E46-B195-F44A0CD8061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74782" y="4202439"/>
            <a:ext cx="3088893" cy="4927068"/>
          </a:xfrm>
          <a:prstGeom prst="rect">
            <a:avLst/>
          </a:prstGeom>
          <a:ln w="3175"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5D229DBF-9F71-5C47-A9B7-E518315934C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4782" y="9129506"/>
            <a:ext cx="3088893" cy="572017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DEFD1976-EB1E-AD4E-A17E-4D032391F602}"/>
              </a:ext>
            </a:extLst>
          </p:cNvPr>
          <p:cNvSpPr/>
          <p:nvPr/>
        </p:nvSpPr>
        <p:spPr>
          <a:xfrm>
            <a:off x="1798402" y="4202439"/>
            <a:ext cx="3241652" cy="5584421"/>
          </a:xfrm>
          <a:prstGeom prst="rect">
            <a:avLst/>
          </a:prstGeom>
          <a:noFill/>
          <a:ln w="127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xmlns="" id="{FAC8A59D-9122-B444-83FA-911D9DC62C32}"/>
              </a:ext>
            </a:extLst>
          </p:cNvPr>
          <p:cNvSpPr/>
          <p:nvPr/>
        </p:nvSpPr>
        <p:spPr>
          <a:xfrm>
            <a:off x="3448087" y="570327"/>
            <a:ext cx="3241652" cy="3530904"/>
          </a:xfrm>
          <a:prstGeom prst="rect">
            <a:avLst/>
          </a:prstGeom>
          <a:noFill/>
          <a:ln w="127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BD0D5BF2-A47B-EC48-8DB8-E9A928757C8F}"/>
              </a:ext>
            </a:extLst>
          </p:cNvPr>
          <p:cNvSpPr/>
          <p:nvPr/>
        </p:nvSpPr>
        <p:spPr>
          <a:xfrm>
            <a:off x="181825" y="680520"/>
            <a:ext cx="3241652" cy="3530904"/>
          </a:xfrm>
          <a:prstGeom prst="rect">
            <a:avLst/>
          </a:prstGeom>
          <a:noFill/>
          <a:ln w="1270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5" name="Google Shape;185;p19">
            <a:extLst>
              <a:ext uri="{FF2B5EF4-FFF2-40B4-BE49-F238E27FC236}">
                <a16:creationId xmlns:a16="http://schemas.microsoft.com/office/drawing/2014/main" xmlns="" id="{0744848E-EF6C-5E42-ADF7-5D8526E13FE4}"/>
              </a:ext>
            </a:extLst>
          </p:cNvPr>
          <p:cNvSpPr txBox="1"/>
          <p:nvPr/>
        </p:nvSpPr>
        <p:spPr>
          <a:xfrm>
            <a:off x="120315" y="83043"/>
            <a:ext cx="6555859" cy="3007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3. Representation of regulated cell death modes in a form of activity flow diagrams including inputs (in green), key players and outputs (in red). (A) Apoptosis, (B) Necroptosis, (C) Autophagy-and lysosome-dependent cell death, (D) </a:t>
            </a:r>
            <a:r>
              <a:rPr lang="en-GB" sz="10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rthanatos</a:t>
            </a: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(E) </a:t>
            </a:r>
            <a:r>
              <a:rPr lang="en-GB" sz="1000" b="1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yroptosis</a:t>
            </a: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(F) Ferroptosis, (G) Mitochondrial permeability transition-driven necrosis.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8577625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21"/>
          <p:cNvSpPr txBox="1"/>
          <p:nvPr/>
        </p:nvSpPr>
        <p:spPr>
          <a:xfrm>
            <a:off x="120326" y="213677"/>
            <a:ext cx="6737674" cy="10055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4. </a:t>
            </a:r>
            <a:r>
              <a:rPr lang="en-US" dirty="0"/>
              <a:t>Comparison of the Regulated Cell Death Map with other pathway resources.</a:t>
            </a:r>
            <a:r>
              <a:rPr lang="en-US" b="1" dirty="0"/>
              <a:t> </a:t>
            </a:r>
            <a:r>
              <a:rPr lang="en-US" dirty="0"/>
              <a:t>(A) Visualization of unique genes distribution from the RCD map across functional modules. (B) Venn diagram shows the intersection of the publications annotating the selected pathways from the sources. </a:t>
            </a:r>
          </a:p>
          <a:p>
            <a:pPr lvl="0">
              <a:buSzPts val="1000"/>
            </a:pP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08" name="Google Shape;208;p2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1825752"/>
            <a:ext cx="6858000" cy="625449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E650742F-BC42-4803-9CED-EFBB4499C9CC}"/>
              </a:ext>
            </a:extLst>
          </p:cNvPr>
          <p:cNvSpPr txBox="1"/>
          <p:nvPr/>
        </p:nvSpPr>
        <p:spPr>
          <a:xfrm>
            <a:off x="2481943" y="8080248"/>
            <a:ext cx="159657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Google Shape;213;p22"/>
          <p:cNvSpPr txBox="1"/>
          <p:nvPr/>
        </p:nvSpPr>
        <p:spPr>
          <a:xfrm>
            <a:off x="120326" y="83050"/>
            <a:ext cx="2748603" cy="579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4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14" name="Google Shape;214;p2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571500" y="662940"/>
            <a:ext cx="5715000" cy="812482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Google Shape;219;p23"/>
          <p:cNvSpPr txBox="1"/>
          <p:nvPr/>
        </p:nvSpPr>
        <p:spPr>
          <a:xfrm>
            <a:off x="120326" y="83050"/>
            <a:ext cx="2748603" cy="579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4C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0" name="Google Shape;220;p2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1838646"/>
            <a:ext cx="6858000" cy="622870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Google Shape;225;p24"/>
          <p:cNvSpPr txBox="1"/>
          <p:nvPr/>
        </p:nvSpPr>
        <p:spPr>
          <a:xfrm>
            <a:off x="120326" y="83050"/>
            <a:ext cx="2748603" cy="579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4D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26" name="Google Shape;226;p2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2727924"/>
            <a:ext cx="6858000" cy="4450151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Google Shape;231;p25"/>
          <p:cNvSpPr txBox="1"/>
          <p:nvPr/>
        </p:nvSpPr>
        <p:spPr>
          <a:xfrm>
            <a:off x="120326" y="83050"/>
            <a:ext cx="2748603" cy="579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</a:t>
            </a: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4E-G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32" name="Google Shape;232;p2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28185" y="3171399"/>
            <a:ext cx="2045220" cy="356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3" name="Google Shape;233;p25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2628297" y="3171399"/>
            <a:ext cx="1909938" cy="3563202"/>
          </a:xfrm>
          <a:prstGeom prst="rect">
            <a:avLst/>
          </a:prstGeom>
          <a:noFill/>
          <a:ln>
            <a:noFill/>
          </a:ln>
        </p:spPr>
      </p:pic>
      <p:pic>
        <p:nvPicPr>
          <p:cNvPr id="234" name="Google Shape;234;p25"/>
          <p:cNvPicPr preferRelativeResize="0"/>
          <p:nvPr/>
        </p:nvPicPr>
        <p:blipFill rotWithShape="1">
          <a:blip r:embed="rId5">
            <a:alphaModFix/>
          </a:blip>
          <a:srcRect/>
          <a:stretch/>
        </p:blipFill>
        <p:spPr>
          <a:xfrm>
            <a:off x="4793127" y="3054527"/>
            <a:ext cx="1918886" cy="3796944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Google Shape;239;p26"/>
          <p:cNvSpPr txBox="1"/>
          <p:nvPr/>
        </p:nvSpPr>
        <p:spPr>
          <a:xfrm>
            <a:off x="120326" y="83049"/>
            <a:ext cx="6518599" cy="11039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lvl="0">
              <a:buSzPts val="1000"/>
            </a:pPr>
            <a:r>
              <a:rPr lang="en-GB" sz="10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S5. </a:t>
            </a:r>
            <a:r>
              <a:rPr lang="en-GB" dirty="0"/>
              <a:t>Boxplots corresponding to the ROMA scores in different modules across the six studies for the comparisons of Alzheimer’s disease and lung cancer.</a:t>
            </a:r>
            <a:endParaRPr sz="1000" b="1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40" name="Google Shape;240;p2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694720" y="5378850"/>
            <a:ext cx="5120127" cy="384009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1" name="Google Shape;241;p26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527847" y="1002291"/>
            <a:ext cx="5919175" cy="4439381"/>
          </a:xfrm>
          <a:prstGeom prst="rect">
            <a:avLst/>
          </a:prstGeom>
          <a:noFill/>
          <a:ln>
            <a:noFill/>
          </a:ln>
        </p:spPr>
      </p:pic>
      <p:sp>
        <p:nvSpPr>
          <p:cNvPr id="242" name="Google Shape;242;p26"/>
          <p:cNvSpPr txBox="1"/>
          <p:nvPr/>
        </p:nvSpPr>
        <p:spPr>
          <a:xfrm>
            <a:off x="370592" y="817625"/>
            <a:ext cx="324128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GB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800" b="1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43" name="Google Shape;243;p26"/>
          <p:cNvSpPr txBox="1"/>
          <p:nvPr/>
        </p:nvSpPr>
        <p:spPr>
          <a:xfrm>
            <a:off x="370592" y="5580111"/>
            <a:ext cx="314510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GB"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8</TotalTime>
  <Words>226</Words>
  <Application>Microsoft Office PowerPoint</Application>
  <PresentationFormat>A4 Paper (210x297 mm)</PresentationFormat>
  <Paragraphs>15</Paragraphs>
  <Slides>12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6" baseType="lpstr">
      <vt:lpstr>Adobe Devanagari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oinfo</dc:creator>
  <cp:lastModifiedBy>mdpi</cp:lastModifiedBy>
  <cp:revision>39</cp:revision>
  <dcterms:modified xsi:type="dcterms:W3CDTF">2020-04-17T00:43:16Z</dcterms:modified>
</cp:coreProperties>
</file>